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036955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46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93" autoAdjust="0"/>
  </p:normalViewPr>
  <p:slideViewPr>
    <p:cSldViewPr>
      <p:cViewPr varScale="1">
        <p:scale>
          <a:sx n="96" d="100"/>
          <a:sy n="96" d="100"/>
        </p:scale>
        <p:origin x="-96" y="-324"/>
      </p:cViewPr>
      <p:guideLst>
        <p:guide orient="horz" pos="2160"/>
        <p:guide pos="32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77716" y="2130426"/>
            <a:ext cx="8814118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55433" y="3886200"/>
            <a:ext cx="725868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043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923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526074" y="274639"/>
            <a:ext cx="2644596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88689" y="274639"/>
            <a:ext cx="776456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71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135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9123" y="4406901"/>
            <a:ext cx="881411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9123" y="2906713"/>
            <a:ext cx="881411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808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88689" y="1600201"/>
            <a:ext cx="5204577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966092" y="1600201"/>
            <a:ext cx="520457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113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535113"/>
            <a:ext cx="45816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18478" y="2174875"/>
            <a:ext cx="45816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267588" y="1535113"/>
            <a:ext cx="45834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267588" y="2174875"/>
            <a:ext cx="45834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980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95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885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3050"/>
            <a:ext cx="341151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054206" y="273051"/>
            <a:ext cx="57968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18478" y="1435101"/>
            <a:ext cx="341151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2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032504" y="4800600"/>
            <a:ext cx="622173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032504" y="612775"/>
            <a:ext cx="622173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032504" y="5367338"/>
            <a:ext cx="622173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2497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600201"/>
            <a:ext cx="933259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18477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F2D01-3673-4FE1-971D-197D45C2334B}" type="datetimeFigureOut">
              <a:rPr lang="ko-KR" altLang="en-US" smtClean="0"/>
              <a:t>2018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542930" y="6356351"/>
            <a:ext cx="328369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431511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31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263" y="1052736"/>
            <a:ext cx="9190101" cy="309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직사각형 4"/>
          <p:cNvSpPr/>
          <p:nvPr/>
        </p:nvSpPr>
        <p:spPr>
          <a:xfrm>
            <a:off x="360040" y="4365104"/>
            <a:ext cx="989385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Differences in gene mutations according to the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CDKN2B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mechanism (deletion and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hypermethylation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. The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y-axis represents the VAF (%) for each mutation for each sample on the x-axis. Each color defines genes associated with a given mutated gene.</a:t>
            </a:r>
            <a:endParaRPr lang="ko-KR" altLang="ko-KR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1298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</TotalTime>
  <Words>46</Words>
  <Application>Microsoft Office PowerPoint</Application>
  <PresentationFormat>사용자 지정</PresentationFormat>
  <Paragraphs>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46</cp:revision>
  <dcterms:created xsi:type="dcterms:W3CDTF">2017-01-18T06:50:24Z</dcterms:created>
  <dcterms:modified xsi:type="dcterms:W3CDTF">2018-09-21T05:39:10Z</dcterms:modified>
</cp:coreProperties>
</file>